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1923" r:id="rId2"/>
    <p:sldId id="191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640"/>
    <p:restoredTop sz="86531"/>
  </p:normalViewPr>
  <p:slideViewPr>
    <p:cSldViewPr snapToGrid="0">
      <p:cViewPr varScale="1">
        <p:scale>
          <a:sx n="64" d="100"/>
          <a:sy n="64" d="100"/>
        </p:scale>
        <p:origin x="462" y="7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SRR &gt; 0.88</c:v>
                </c:pt>
              </c:strCache>
            </c:strRef>
          </c:tx>
          <c:spPr>
            <a:solidFill>
              <a:schemeClr val="tx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0.6</c:v>
                  </c:pt>
                  <c:pt idx="1">
                    <c:v>0.2</c:v>
                  </c:pt>
                </c:numCache>
              </c:numRef>
            </c:plus>
            <c:minus>
              <c:numRef>
                <c:f>Sheet1!$E$2:$E$4</c:f>
                <c:numCache>
                  <c:formatCode>General</c:formatCode>
                  <c:ptCount val="3"/>
                  <c:pt idx="0">
                    <c:v>0.6</c:v>
                  </c:pt>
                  <c:pt idx="1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: Global stress MBF</c:v>
                </c:pt>
                <c:pt idx="1">
                  <c:v>B: Global rest MBF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.5</c:v>
                </c:pt>
                <c:pt idx="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1F6-CE43-B749-4E1BF93C76C9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RR ≦ 0.88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>
              <a:glow rad="127000">
                <a:schemeClr val="bg1"/>
              </a:glo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Sheet1!$E$6:$E$8</c:f>
                <c:numCache>
                  <c:formatCode>General</c:formatCode>
                  <c:ptCount val="3"/>
                  <c:pt idx="0">
                    <c:v>0.5</c:v>
                  </c:pt>
                  <c:pt idx="1">
                    <c:v>0.3</c:v>
                  </c:pt>
                </c:numCache>
              </c:numRef>
            </c:plus>
            <c:minus>
              <c:numRef>
                <c:f>Sheet1!$E$6:$E$8</c:f>
                <c:numCache>
                  <c:formatCode>General</c:formatCode>
                  <c:ptCount val="3"/>
                  <c:pt idx="0">
                    <c:v>0.5</c:v>
                  </c:pt>
                  <c:pt idx="1">
                    <c:v>0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: Global stress MBF</c:v>
                </c:pt>
                <c:pt idx="1">
                  <c:v>B: Global rest MBF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2.1</c:v>
                </c:pt>
                <c:pt idx="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1F6-CE43-B749-4E1BF93C76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257424"/>
        <c:axId val="238087104"/>
      </c:barChart>
      <c:catAx>
        <c:axId val="29925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8087104"/>
        <c:crosses val="autoZero"/>
        <c:auto val="1"/>
        <c:lblAlgn val="ctr"/>
        <c:lblOffset val="100"/>
        <c:noMultiLvlLbl val="0"/>
      </c:catAx>
      <c:valAx>
        <c:axId val="238087104"/>
        <c:scaling>
          <c:orientation val="minMax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257424"/>
        <c:crosses val="autoZero"/>
        <c:crossBetween val="between"/>
      </c:valAx>
      <c:spPr>
        <a:noFill/>
        <a:ln w="25400">
          <a:noFill/>
        </a:ln>
        <a:effectLst>
          <a:glow rad="127000">
            <a:schemeClr val="bg1"/>
          </a:glow>
        </a:effectLst>
      </c:spPr>
    </c:plotArea>
    <c:legend>
      <c:legendPos val="b"/>
      <c:layout>
        <c:manualLayout>
          <c:xMode val="edge"/>
          <c:yMode val="edge"/>
          <c:x val="0.50162191715245363"/>
          <c:y val="0.95492520686795779"/>
          <c:w val="0.49837808284754631"/>
          <c:h val="4.50747931320422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egative SSO</c:v>
                </c:pt>
              </c:strCache>
            </c:strRef>
          </c:tx>
          <c:spPr>
            <a:solidFill>
              <a:schemeClr val="tx2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0.7</c:v>
                  </c:pt>
                </c:numCache>
              </c:numRef>
            </c:plus>
            <c:minus>
              <c:numRef>
                <c:f>Sheet1!$E$2:$E$4</c:f>
                <c:numCache>
                  <c:formatCode>General</c:formatCode>
                  <c:ptCount val="3"/>
                  <c:pt idx="0">
                    <c:v>0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</c:f>
              <c:strCache>
                <c:ptCount val="1"/>
                <c:pt idx="0">
                  <c:v>C: Global MFR</c:v>
                </c:pt>
              </c:strCache>
            </c:strRef>
          </c:cat>
          <c:val>
            <c:numRef>
              <c:f>Sheet1!$B$2</c:f>
              <c:numCache>
                <c:formatCode>General</c:formatCode>
                <c:ptCount val="1"/>
                <c:pt idx="0">
                  <c:v>1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AF8-5645-9013-0BE5943A37D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positive SS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>
              <a:glow rad="127000">
                <a:schemeClr val="bg1"/>
              </a:glo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Sheet1!$E$6:$E$8</c:f>
                <c:numCache>
                  <c:formatCode>General</c:formatCode>
                  <c:ptCount val="3"/>
                  <c:pt idx="0">
                    <c:v>0.7</c:v>
                  </c:pt>
                </c:numCache>
              </c:numRef>
            </c:plus>
            <c:minus>
              <c:numRef>
                <c:f>Sheet1!$E$6:$E$8</c:f>
                <c:numCache>
                  <c:formatCode>General</c:formatCode>
                  <c:ptCount val="3"/>
                  <c:pt idx="0">
                    <c:v>0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</c:f>
              <c:strCache>
                <c:ptCount val="1"/>
                <c:pt idx="0">
                  <c:v>C: Global MFR</c:v>
                </c:pt>
              </c:strCache>
            </c:strRef>
          </c:cat>
          <c:val>
            <c:numRef>
              <c:f>Sheet1!$C$2</c:f>
              <c:numCache>
                <c:formatCode>General</c:formatCode>
                <c:ptCount val="1"/>
                <c:pt idx="0">
                  <c:v>2.299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AF8-5645-9013-0BE5943A37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9761736"/>
        <c:axId val="299762120"/>
      </c:barChart>
      <c:catAx>
        <c:axId val="299761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762120"/>
        <c:crosses val="autoZero"/>
        <c:auto val="1"/>
        <c:lblAlgn val="ctr"/>
        <c:lblOffset val="100"/>
        <c:noMultiLvlLbl val="0"/>
      </c:catAx>
      <c:valAx>
        <c:axId val="299762120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9761736"/>
        <c:crosses val="autoZero"/>
        <c:crossBetween val="between"/>
      </c:valAx>
      <c:spPr>
        <a:noFill/>
        <a:ln>
          <a:noFill/>
        </a:ln>
        <a:effectLst>
          <a:glow rad="127000">
            <a:schemeClr val="bg1"/>
          </a:glow>
        </a:effectLst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E61071-28A8-7E46-9B24-99CE288E472C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6ED5D7-9EA5-E44E-8D59-88167A2889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3599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19E58389-13DB-A750-B411-445301ACB18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xmlns="" id="{24E51557-4679-FB6E-6250-DBB3DAC3C1D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xmlns="" id="{8AA95C69-2D3F-0DA9-AB1A-548F84BBC9D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>
              <a:effectLst/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07F98CEF-55A4-B5F3-C03C-5695AA22B84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ED5D7-9EA5-E44E-8D59-88167A2889E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5739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6ED5D7-9EA5-E44E-8D59-88167A2889E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9180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831B5F3-3C40-2BEB-7395-11131CAF8A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2601C850-6929-C06B-118D-B2DC55B385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209C333F-0DF9-3199-411D-ADEEE630C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46CB6CB-1C8D-0F48-5CA1-8BAE081FB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B4E3C57-EB4A-CFEC-BBED-1F8BF02A4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533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B3446D7-A417-B940-518C-71C67AD3B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8A889380-8C10-83F3-B127-23609AFF08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459897F-0A5D-2E13-D1B8-E3EE1A52F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A2D0E4B-13F2-7EF6-5B90-135E8CB63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2CE3D41-1A46-9A96-B31B-5781A12F7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3198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9789B75C-56CE-06B8-4891-4DD0CDFBC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8F192FD-948D-9629-BD3F-F28CBE3A52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9A8AD6E-5C1F-3EE5-34C5-600FD18A7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EA12F72E-AAFE-EADA-1A36-2AC6AE7D4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1FFA925-9197-8004-7CBE-193BC6593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41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9940F8E9-52C9-F5DA-D8C8-7D03DDE90D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F10AF773-238C-F07C-5835-48FE2EA2DE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4B7A0E0D-EB02-4D98-0490-1831AEC25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3A1404E-5ECE-FC2A-006A-43FE55483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FC6BBE90-7E34-E622-59FC-7D0C7CDEA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398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AC310C1-FC04-1A07-072B-E4B0F2304C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E6F74F8F-3766-B74F-C34E-0A4D7E738C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0FE0D43-7C80-63B9-857A-B61FCE9E7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FE16D6A-F3DF-CDBC-8837-6F5D6D6C4A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DCF1918-3090-4646-DBC3-F3B438011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671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71CF6A1-58C5-1E84-0C5B-150E4B51B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E61753D0-FD1F-E3F9-FE1E-3DBC1B5054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EE2A1E37-61AB-BFC5-CC16-7259523392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ECB4249-62FD-87AD-E9FE-90A484547D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A5DE0B22-8DE6-82C4-5413-6D688DF3C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DD8D717-0CC8-8E96-ADF2-6D35C6AA6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577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9F11870-4FFC-6A80-F2A9-F0786280F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AE78CEC-2C02-3E33-E3F6-9D00F36471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82AF1ED5-C16A-9283-3AB0-3233051DE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1B589640-6C4B-A1B2-9982-37158FE4B3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EF33449F-4E24-E70B-194B-B7FEEB3A7D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02A63CD1-664B-7D4E-E54E-747DFCF1D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D18D05CA-C933-9FDC-DAFC-B861F24B5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F8A9A77E-C3DB-C607-B894-622B33346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3556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A12C6760-9F01-5818-1918-22FD8A44F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454E0877-B1E8-4C34-2918-AB8C16980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A7D23985-1209-C3ED-83F2-C3E59D0DC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20408365-2C95-BC19-5D9B-11413236B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216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A202B760-1194-67C6-37E9-113DD84577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9D97099E-9C63-3FB9-DC89-D90A01BF9D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FF16D7E8-8457-CCEF-43EF-EC3037B58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3402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EE7445A-F81B-4190-4355-2F165C567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3A7C97E0-32C3-63AB-B5A5-C028B006A6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6BA3A884-F832-3B18-B696-871D5435E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278E8EC8-CD7D-02C9-A03A-3A7802639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45C0601A-8D63-322D-7FC2-11E6BFC33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66363DA3-5706-A2DD-A2D4-FA7E8C5E9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010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430D0CC-A776-D4CF-490D-829BE22684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9EAA87E9-65C0-E916-3C11-09C2A8941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E674C603-EFBE-4279-B5B0-F39DE34A89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5AC9300-1A96-EA31-CA66-A221700B0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1A3DA7B-1D5F-E7F4-C977-7B17710C3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12BC4A8E-BFEE-F8E4-E0BD-BFBCFEA464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103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BB95D76D-D609-034D-7316-5FD648129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68084C6D-7BE1-41FE-765B-1B8271661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F63C5E2E-E9E3-86AB-889A-7E4437ABEA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1BDBE1-06CD-3746-900E-0199852EA378}" type="datetimeFigureOut">
              <a:rPr kumimoji="1" lang="ja-JP" altLang="en-US" smtClean="0"/>
              <a:t>2025/3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4C5C5232-51F2-92FE-4C75-7C69B2C531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098B6C4B-8D90-CA71-67BB-EB2F15D765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A2FB47-2C5C-FE4F-B49B-96DF127FE2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858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png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380328B8-7719-C49B-6A0C-313D1D17E1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xmlns="" id="{26045A49-6C12-1863-2BC5-0B09DB0A94EC}"/>
              </a:ext>
            </a:extLst>
          </p:cNvPr>
          <p:cNvGraphicFramePr/>
          <p:nvPr/>
        </p:nvGraphicFramePr>
        <p:xfrm>
          <a:off x="1371601" y="811867"/>
          <a:ext cx="5498123" cy="5987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7727AB87-9385-D0FC-03ED-5AFFCAFCFD80}"/>
              </a:ext>
            </a:extLst>
          </p:cNvPr>
          <p:cNvSpPr txBox="1"/>
          <p:nvPr/>
        </p:nvSpPr>
        <p:spPr>
          <a:xfrm>
            <a:off x="401464" y="657978"/>
            <a:ext cx="12282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solidFill>
                  <a:srgbClr val="000000"/>
                </a:solidFill>
                <a:effectLst/>
                <a:latin typeface="Helvetica" pitchFamily="2" charset="0"/>
                <a:ea typeface="游明朝" panose="02020400000000000000" pitchFamily="18" charset="-128"/>
              </a:rPr>
              <a:t>ml·min-1·g-1 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2" name="左大かっこ 11">
            <a:extLst>
              <a:ext uri="{FF2B5EF4-FFF2-40B4-BE49-F238E27FC236}">
                <a16:creationId xmlns:a16="http://schemas.microsoft.com/office/drawing/2014/main" xmlns="" id="{DE6790BF-6B15-F257-2093-B05A039D70C9}"/>
              </a:ext>
            </a:extLst>
          </p:cNvPr>
          <p:cNvSpPr/>
          <p:nvPr/>
        </p:nvSpPr>
        <p:spPr>
          <a:xfrm rot="5400000">
            <a:off x="2910074" y="833616"/>
            <a:ext cx="142876" cy="814386"/>
          </a:xfrm>
          <a:prstGeom prst="leftBracket">
            <a:avLst/>
          </a:prstGeom>
          <a:ln w="127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C16B0CEA-6E48-8F93-C021-44CAF0B49DDA}"/>
              </a:ext>
            </a:extLst>
          </p:cNvPr>
          <p:cNvSpPr txBox="1"/>
          <p:nvPr/>
        </p:nvSpPr>
        <p:spPr>
          <a:xfrm>
            <a:off x="2574315" y="811939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p &lt; 0.001</a:t>
            </a:r>
            <a:endParaRPr kumimoji="1" lang="ja-JP" altLang="en-US" sz="1200"/>
          </a:p>
        </p:txBody>
      </p:sp>
      <p:sp>
        <p:nvSpPr>
          <p:cNvPr id="15" name="左大かっこ 14">
            <a:extLst>
              <a:ext uri="{FF2B5EF4-FFF2-40B4-BE49-F238E27FC236}">
                <a16:creationId xmlns:a16="http://schemas.microsoft.com/office/drawing/2014/main" xmlns="" id="{4284625A-43FF-2C37-2762-9DD0276E1E3B}"/>
              </a:ext>
            </a:extLst>
          </p:cNvPr>
          <p:cNvSpPr/>
          <p:nvPr/>
        </p:nvSpPr>
        <p:spPr>
          <a:xfrm rot="5400000">
            <a:off x="5438412" y="2630175"/>
            <a:ext cx="142876" cy="814386"/>
          </a:xfrm>
          <a:prstGeom prst="leftBracket">
            <a:avLst/>
          </a:prstGeom>
          <a:ln w="127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BE73499F-923C-782A-DB38-0A658297BB22}"/>
              </a:ext>
            </a:extLst>
          </p:cNvPr>
          <p:cNvSpPr txBox="1"/>
          <p:nvPr/>
        </p:nvSpPr>
        <p:spPr>
          <a:xfrm>
            <a:off x="5125770" y="2575165"/>
            <a:ext cx="7681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p = 0.57</a:t>
            </a:r>
            <a:endParaRPr kumimoji="1" lang="ja-JP" altLang="en-US" sz="12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863BAC9B-E3A8-6424-951A-2B3EA48E6069}"/>
              </a:ext>
            </a:extLst>
          </p:cNvPr>
          <p:cNvSpPr txBox="1"/>
          <p:nvPr/>
        </p:nvSpPr>
        <p:spPr>
          <a:xfrm>
            <a:off x="-23878" y="0"/>
            <a:ext cx="30267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Helvetica" pitchFamily="2" charset="0"/>
              </a:rPr>
              <a:t>Supplementary Fig.1</a:t>
            </a:r>
            <a:endParaRPr kumimoji="1" lang="ja-JP" altLang="en-US" sz="2400">
              <a:latin typeface="Helvetica" pitchFamily="2" charset="0"/>
            </a:endParaRPr>
          </a:p>
        </p:txBody>
      </p:sp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xmlns="" id="{E45904A6-0B3F-0246-A08D-D8A5A92575A9}"/>
              </a:ext>
            </a:extLst>
          </p:cNvPr>
          <p:cNvGraphicFramePr/>
          <p:nvPr/>
        </p:nvGraphicFramePr>
        <p:xfrm>
          <a:off x="7288187" y="811867"/>
          <a:ext cx="3258677" cy="5624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左大かっこ 7">
            <a:extLst>
              <a:ext uri="{FF2B5EF4-FFF2-40B4-BE49-F238E27FC236}">
                <a16:creationId xmlns:a16="http://schemas.microsoft.com/office/drawing/2014/main" xmlns="" id="{B3EE7FAC-83EA-E867-4946-9620F652230B}"/>
              </a:ext>
            </a:extLst>
          </p:cNvPr>
          <p:cNvSpPr/>
          <p:nvPr/>
        </p:nvSpPr>
        <p:spPr>
          <a:xfrm rot="5400000">
            <a:off x="8998381" y="423311"/>
            <a:ext cx="142876" cy="814386"/>
          </a:xfrm>
          <a:prstGeom prst="leftBracket">
            <a:avLst/>
          </a:prstGeom>
          <a:ln w="127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6C2A9404-4E54-85F1-62BA-74C73647DBF0}"/>
              </a:ext>
            </a:extLst>
          </p:cNvPr>
          <p:cNvSpPr txBox="1"/>
          <p:nvPr/>
        </p:nvSpPr>
        <p:spPr>
          <a:xfrm>
            <a:off x="8623893" y="387467"/>
            <a:ext cx="8531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p = 0.004</a:t>
            </a:r>
            <a:endParaRPr kumimoji="1" lang="ja-JP" altLang="en-US" sz="120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xmlns="" id="{F457FA24-F1A3-6960-057E-6FAD01DF01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58335" y="6526121"/>
            <a:ext cx="889000" cy="241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1752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 が含まれている画像&#10;&#10;自動的に生成された説明">
            <a:extLst>
              <a:ext uri="{FF2B5EF4-FFF2-40B4-BE49-F238E27FC236}">
                <a16:creationId xmlns:a16="http://schemas.microsoft.com/office/drawing/2014/main" xmlns="" id="{5301B8BA-7BF0-162F-60C9-9DD639099C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7662" y="0"/>
            <a:ext cx="9236676" cy="685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8B00A6DB-0A8D-5F72-1D88-4B1D59EDD4B4}"/>
              </a:ext>
            </a:extLst>
          </p:cNvPr>
          <p:cNvSpPr txBox="1"/>
          <p:nvPr/>
        </p:nvSpPr>
        <p:spPr>
          <a:xfrm>
            <a:off x="-23878" y="0"/>
            <a:ext cx="30267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Helvetica" pitchFamily="2" charset="0"/>
              </a:rPr>
              <a:t>Supplementary </a:t>
            </a:r>
            <a:r>
              <a:rPr kumimoji="1" lang="en-US" altLang="ja-JP" sz="2400">
                <a:latin typeface="Helvetica" pitchFamily="2" charset="0"/>
              </a:rPr>
              <a:t>Fig.2</a:t>
            </a:r>
            <a:endParaRPr kumimoji="1" lang="ja-JP" altLang="en-US" sz="24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0766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28</TotalTime>
  <Words>16</Words>
  <Application>Microsoft Office PowerPoint</Application>
  <PresentationFormat>Widescreen</PresentationFormat>
  <Paragraphs>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Helvetica</vt:lpstr>
      <vt:lpstr>游明朝</vt:lpstr>
      <vt:lpstr>Office テーマ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ntaro OHARA</dc:creator>
  <cp:lastModifiedBy>Raja S Subramanian G</cp:lastModifiedBy>
  <cp:revision>270</cp:revision>
  <dcterms:created xsi:type="dcterms:W3CDTF">2024-06-30T12:53:19Z</dcterms:created>
  <dcterms:modified xsi:type="dcterms:W3CDTF">2025-03-18T12:45:24Z</dcterms:modified>
</cp:coreProperties>
</file>